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7" d="100"/>
          <a:sy n="97" d="100"/>
        </p:scale>
        <p:origin x="-96" y="-6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11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950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9556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5694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48349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47877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79700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5148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0695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34230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5922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DD215-A467-4DB9-9187-FF86D22A4035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AEF87-0C1F-4307-86F1-42AC80F3AE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18656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5888492" y="7811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vdac3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589101" y="7811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xmlns="" id="{BEB07DF2-4A6B-9F11-4395-60ED5E5E01FA}"/>
              </a:ext>
            </a:extLst>
          </p:cNvPr>
          <p:cNvSpPr txBox="1"/>
          <p:nvPr/>
        </p:nvSpPr>
        <p:spPr>
          <a:xfrm>
            <a:off x="7531511" y="3226417"/>
            <a:ext cx="45130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Figure S1. Images of a single flower of WT,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itchFamily="18" charset="0"/>
              </a:rPr>
              <a:t>hsp70-16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 and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itchFamily="18" charset="0"/>
              </a:rPr>
              <a:t>vadc3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 grown at 22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C and 27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C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The fused sepal phenotype only appeared in sepal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itchFamily="18" charset="0"/>
              </a:rPr>
              <a:t>hsp70-16 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grown at 22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C (Upper panel), while it appeared in sepals of both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itchFamily="18" charset="0"/>
              </a:rPr>
              <a:t>hsp70-16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itchFamily="18" charset="0"/>
              </a:rPr>
              <a:t>vdac3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 grown at 27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dirty="0">
                <a:latin typeface="Times New Roman" panose="02020603050405020304" pitchFamily="18" charset="0"/>
                <a:cs typeface="Times New Roman" pitchFamily="18" charset="0"/>
              </a:rPr>
              <a:t>C (Bottom panel)</a:t>
            </a:r>
          </a:p>
        </p:txBody>
      </p:sp>
      <p:sp>
        <p:nvSpPr>
          <p:cNvPr id="6" name="TextBox 21">
            <a:extLst>
              <a:ext uri="{FF2B5EF4-FFF2-40B4-BE49-F238E27FC236}">
                <a16:creationId xmlns:a16="http://schemas.microsoft.com/office/drawing/2014/main" xmlns="" id="{0F8DDD9A-4093-6A16-68B6-553D601A118C}"/>
              </a:ext>
            </a:extLst>
          </p:cNvPr>
          <p:cNvSpPr txBox="1"/>
          <p:nvPr/>
        </p:nvSpPr>
        <p:spPr>
          <a:xfrm>
            <a:off x="4089565" y="7811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hsp70-16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3">
            <a:extLst>
              <a:ext uri="{FF2B5EF4-FFF2-40B4-BE49-F238E27FC236}">
                <a16:creationId xmlns:a16="http://schemas.microsoft.com/office/drawing/2014/main" xmlns="" id="{273E9107-7572-15E0-8FA2-2E5602A8C2D9}"/>
              </a:ext>
            </a:extLst>
          </p:cNvPr>
          <p:cNvSpPr txBox="1"/>
          <p:nvPr/>
        </p:nvSpPr>
        <p:spPr>
          <a:xfrm rot="16200000">
            <a:off x="1402688" y="5076814"/>
            <a:ext cx="774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Stage 16 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27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C</a:t>
            </a:r>
            <a:endParaRPr lang="en-US" sz="1200" b="1" i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sp>
        <p:nvSpPr>
          <p:cNvPr id="10" name="TextBox 3">
            <a:extLst>
              <a:ext uri="{FF2B5EF4-FFF2-40B4-BE49-F238E27FC236}">
                <a16:creationId xmlns:a16="http://schemas.microsoft.com/office/drawing/2014/main" xmlns="" id="{1E3228FF-E224-7C4E-08AC-D7124000188D}"/>
              </a:ext>
            </a:extLst>
          </p:cNvPr>
          <p:cNvSpPr txBox="1"/>
          <p:nvPr/>
        </p:nvSpPr>
        <p:spPr>
          <a:xfrm rot="16200000">
            <a:off x="1421924" y="1616001"/>
            <a:ext cx="7360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Stage 14</a:t>
            </a:r>
          </a:p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 22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itchFamily="18" charset="0"/>
              </a:rPr>
              <a:t>o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itchFamily="18" charset="0"/>
              </a:rPr>
              <a:t>C</a:t>
            </a:r>
            <a:endParaRPr lang="en-US" sz="1200" b="1" i="1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5BF050A1-35CC-A7F5-6D61-6ADAF1EF7DB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5583" t="21209" r="10259"/>
          <a:stretch/>
        </p:blipFill>
        <p:spPr>
          <a:xfrm flipH="1">
            <a:off x="3773163" y="453810"/>
            <a:ext cx="1728000" cy="30960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0D38332C-9244-C8AB-A7AE-DED61398D02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 xmlns="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5795" t="17407" r="23233"/>
          <a:stretch/>
        </p:blipFill>
        <p:spPr>
          <a:xfrm>
            <a:off x="2014108" y="3568820"/>
            <a:ext cx="1728000" cy="3096000"/>
          </a:xfrm>
          <a:prstGeom prst="rect">
            <a:avLst/>
          </a:prstGeom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xmlns="" id="{D230B7AF-4F7A-376A-2697-3F5CD9C31D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014108" y="447442"/>
            <a:ext cx="1726815" cy="309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0">
            <a:extLst>
              <a:ext uri="{FF2B5EF4-FFF2-40B4-BE49-F238E27FC236}">
                <a16:creationId xmlns:a16="http://schemas.microsoft.com/office/drawing/2014/main" xmlns="" id="{CE9392BA-8B70-5AED-270A-1C1E16B6EF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049620" y="6344728"/>
            <a:ext cx="955589" cy="269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7">
            <a:extLst>
              <a:ext uri="{FF2B5EF4-FFF2-40B4-BE49-F238E27FC236}">
                <a16:creationId xmlns:a16="http://schemas.microsoft.com/office/drawing/2014/main" xmlns="" id="{AA329F80-A4E6-3356-7781-FC9F11EBF5F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545377" y="3568820"/>
            <a:ext cx="1728000" cy="309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2">
            <a:extLst>
              <a:ext uri="{FF2B5EF4-FFF2-40B4-BE49-F238E27FC236}">
                <a16:creationId xmlns:a16="http://schemas.microsoft.com/office/drawing/2014/main" xmlns="" id="{FAA1751A-AD68-5DDC-01A0-F8BAF928D2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692992" y="6396491"/>
            <a:ext cx="917635" cy="2168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547DD34B-C838-CDEB-D8A6-80D82EA63BF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0761" t="44309" r="15088" b="7195"/>
          <a:stretch/>
        </p:blipFill>
        <p:spPr>
          <a:xfrm>
            <a:off x="3780928" y="3568820"/>
            <a:ext cx="1728000" cy="3096000"/>
          </a:xfrm>
          <a:prstGeom prst="rect">
            <a:avLst/>
          </a:prstGeom>
        </p:spPr>
      </p:pic>
      <p:pic>
        <p:nvPicPr>
          <p:cNvPr id="14" name="Picture 12">
            <a:extLst>
              <a:ext uri="{FF2B5EF4-FFF2-40B4-BE49-F238E27FC236}">
                <a16:creationId xmlns:a16="http://schemas.microsoft.com/office/drawing/2014/main" xmlns="" id="{071035E9-BFF0-C363-64DF-CB06832F74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96340" y="6400294"/>
            <a:ext cx="917635" cy="2168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7420DBAB-5E4A-DB39-2737-BB3C9E4046B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3654" t="5114" r="24026"/>
          <a:stretch/>
        </p:blipFill>
        <p:spPr>
          <a:xfrm>
            <a:off x="5545377" y="447442"/>
            <a:ext cx="1728000" cy="3096000"/>
          </a:xfrm>
          <a:prstGeom prst="rect">
            <a:avLst/>
          </a:prstGeom>
        </p:spPr>
      </p:pic>
      <p:pic>
        <p:nvPicPr>
          <p:cNvPr id="16" name="Picture 10">
            <a:extLst>
              <a:ext uri="{FF2B5EF4-FFF2-40B4-BE49-F238E27FC236}">
                <a16:creationId xmlns:a16="http://schemas.microsoft.com/office/drawing/2014/main" xmlns="" id="{1AC32FA7-587D-3349-D637-1E0A49F5EB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92932" y="3226416"/>
            <a:ext cx="955589" cy="269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0">
            <a:extLst>
              <a:ext uri="{FF2B5EF4-FFF2-40B4-BE49-F238E27FC236}">
                <a16:creationId xmlns:a16="http://schemas.microsoft.com/office/drawing/2014/main" xmlns="" id="{D107A7D0-D670-A0DF-D423-5D9A5D2F3A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040742" y="3235294"/>
            <a:ext cx="955589" cy="269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" name="Picture 10">
            <a:extLst>
              <a:ext uri="{FF2B5EF4-FFF2-40B4-BE49-F238E27FC236}">
                <a16:creationId xmlns:a16="http://schemas.microsoft.com/office/drawing/2014/main" xmlns="" id="{1EDB7AC8-E64B-13FF-0965-0CBE4E4E33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696063" y="3235294"/>
            <a:ext cx="955589" cy="269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xmlns="" val="3949556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64</Words>
  <Application>Microsoft Office PowerPoint</Application>
  <PresentationFormat>自定义</PresentationFormat>
  <Paragraphs>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user</cp:lastModifiedBy>
  <cp:revision>13</cp:revision>
  <dcterms:created xsi:type="dcterms:W3CDTF">2023-03-06T01:28:18Z</dcterms:created>
  <dcterms:modified xsi:type="dcterms:W3CDTF">2023-04-19T05:52:07Z</dcterms:modified>
</cp:coreProperties>
</file>